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18" r:id="rId2"/>
    <p:sldId id="319" r:id="rId3"/>
    <p:sldId id="292" r:id="rId4"/>
  </p:sldIdLst>
  <p:sldSz cx="12192000" cy="6858000"/>
  <p:notesSz cx="6797675" cy="98726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3DBD8"/>
    <a:srgbClr val="8FC3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51" autoAdjust="0"/>
    <p:restoredTop sz="96357" autoAdjust="0"/>
  </p:normalViewPr>
  <p:slideViewPr>
    <p:cSldViewPr snapToGrid="0">
      <p:cViewPr varScale="1">
        <p:scale>
          <a:sx n="110" d="100"/>
          <a:sy n="110" d="100"/>
        </p:scale>
        <p:origin x="822" y="96"/>
      </p:cViewPr>
      <p:guideLst/>
    </p:cSldViewPr>
  </p:slideViewPr>
  <p:outlineViewPr>
    <p:cViewPr>
      <p:scale>
        <a:sx n="33" d="100"/>
        <a:sy n="33" d="100"/>
      </p:scale>
      <p:origin x="0" y="-2136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5348"/>
          </a:xfrm>
          <a:prstGeom prst="rect">
            <a:avLst/>
          </a:prstGeom>
        </p:spPr>
        <p:txBody>
          <a:bodyPr vert="horz" lIns="91427" tIns="45714" rIns="91427" bIns="45714" rtlCol="0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5348"/>
          </a:xfrm>
          <a:prstGeom prst="rect">
            <a:avLst/>
          </a:prstGeom>
        </p:spPr>
        <p:txBody>
          <a:bodyPr vert="horz" lIns="91427" tIns="45714" rIns="91427" bIns="45714" rtlCol="0"/>
          <a:lstStyle>
            <a:lvl1pPr algn="r">
              <a:defRPr sz="1200"/>
            </a:lvl1pPr>
          </a:lstStyle>
          <a:p>
            <a:fld id="{9B9E4514-298E-4B20-9EF1-4492D8C3A74D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38150" y="1233488"/>
            <a:ext cx="5921375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7" tIns="45714" rIns="91427" bIns="45714" rtlCol="0" anchor="ctr"/>
          <a:lstStyle/>
          <a:p>
            <a:endParaRPr lang="en-S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220"/>
            <a:ext cx="5438140" cy="3887361"/>
          </a:xfrm>
          <a:prstGeom prst="rect">
            <a:avLst/>
          </a:prstGeom>
        </p:spPr>
        <p:txBody>
          <a:bodyPr vert="horz" lIns="91427" tIns="45714" rIns="91427" bIns="4571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377318"/>
            <a:ext cx="2945659" cy="495347"/>
          </a:xfrm>
          <a:prstGeom prst="rect">
            <a:avLst/>
          </a:prstGeom>
        </p:spPr>
        <p:txBody>
          <a:bodyPr vert="horz" lIns="91427" tIns="45714" rIns="91427" bIns="45714" rtlCol="0" anchor="b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377318"/>
            <a:ext cx="2945659" cy="495347"/>
          </a:xfrm>
          <a:prstGeom prst="rect">
            <a:avLst/>
          </a:prstGeom>
        </p:spPr>
        <p:txBody>
          <a:bodyPr vert="horz" lIns="91427" tIns="45714" rIns="91427" bIns="45714" rtlCol="0" anchor="b"/>
          <a:lstStyle>
            <a:lvl1pPr algn="r">
              <a:defRPr sz="1200"/>
            </a:lvl1pPr>
          </a:lstStyle>
          <a:p>
            <a:fld id="{1FE143E3-3D17-4D5F-812A-636839D8C93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9355771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E143E3-3D17-4D5F-812A-636839D8C93C}" type="slidenum">
              <a:rPr lang="en-SG" smtClean="0"/>
              <a:t>1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9200178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E143E3-3D17-4D5F-812A-636839D8C93C}" type="slidenum">
              <a:rPr lang="en-SG" smtClean="0"/>
              <a:t>2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6953530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774128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54838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881932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918388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557448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815871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7884653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266335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362007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534648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895896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F6006-17C9-4AAF-BC3D-7F4AA584F051}" type="datetimeFigureOut">
              <a:rPr lang="en-SG" smtClean="0"/>
              <a:t>10/12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0DD27-FE00-475F-9790-2A9CB612445E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580265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6.jpe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274700" y="1844987"/>
            <a:ext cx="1240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ig. 2ai</a:t>
            </a:r>
            <a:endParaRPr lang="en-SG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454437" y="1076325"/>
            <a:ext cx="9534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ry Fig. S1. </a:t>
            </a:r>
            <a:r>
              <a:rPr lang="en-US" dirty="0"/>
              <a:t>Original </a:t>
            </a:r>
            <a:r>
              <a:rPr lang="en-SG" dirty="0"/>
              <a:t>unmodified images with relevant rulers for Figure 2ai</a:t>
            </a:r>
            <a:r>
              <a:rPr lang="en-SG"/>
              <a:t>, 2aii </a:t>
            </a:r>
            <a:r>
              <a:rPr lang="en-SG" dirty="0"/>
              <a:t>and 5b.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B904C75-7D58-4C1D-9016-4D479168B002}"/>
              </a:ext>
            </a:extLst>
          </p:cNvPr>
          <p:cNvSpPr txBox="1"/>
          <p:nvPr/>
        </p:nvSpPr>
        <p:spPr>
          <a:xfrm>
            <a:off x="1514821" y="1844987"/>
            <a:ext cx="685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Male</a:t>
            </a:r>
            <a:endParaRPr lang="en-SG" b="1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3640388A-B5DB-4408-A970-9439E7B8E382}"/>
              </a:ext>
            </a:extLst>
          </p:cNvPr>
          <p:cNvGrpSpPr/>
          <p:nvPr/>
        </p:nvGrpSpPr>
        <p:grpSpPr>
          <a:xfrm>
            <a:off x="593720" y="2092529"/>
            <a:ext cx="11004559" cy="3214434"/>
            <a:chOff x="593720" y="2092529"/>
            <a:chExt cx="11004559" cy="321443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360F9AE-58BA-438E-988E-EE8C6152003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7523" y="2606201"/>
              <a:ext cx="3596952" cy="2700762"/>
            </a:xfrm>
            <a:prstGeom prst="rect">
              <a:avLst/>
            </a:prstGeom>
          </p:spPr>
        </p:pic>
        <p:pic>
          <p:nvPicPr>
            <p:cNvPr id="5" name="Picture 4" descr="A picture containing text, cat, black&#10;&#10;Description automatically generated">
              <a:extLst>
                <a:ext uri="{FF2B5EF4-FFF2-40B4-BE49-F238E27FC236}">
                  <a16:creationId xmlns:a16="http://schemas.microsoft.com/office/drawing/2014/main" id="{218C28D6-3A95-4B85-9A51-E9DFD568E8A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8448278" y="2147493"/>
              <a:ext cx="2700001" cy="36000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89547BF-6B26-47FC-B841-8BAE84FEBB0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593720" y="2601162"/>
              <a:ext cx="3600000" cy="2700000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8F2F520A-E153-4C9F-9FCD-A541D0070107}"/>
                </a:ext>
              </a:extLst>
            </p:cNvPr>
            <p:cNvGrpSpPr/>
            <p:nvPr/>
          </p:nvGrpSpPr>
          <p:grpSpPr>
            <a:xfrm>
              <a:off x="1423367" y="2092529"/>
              <a:ext cx="9867927" cy="580129"/>
              <a:chOff x="1479672" y="1486027"/>
              <a:chExt cx="9867927" cy="580129"/>
            </a:xfrm>
          </p:grpSpPr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8C12F992-8AA5-414C-86D8-D22D0017F611}"/>
                  </a:ext>
                </a:extLst>
              </p:cNvPr>
              <p:cNvGrpSpPr/>
              <p:nvPr/>
            </p:nvGrpSpPr>
            <p:grpSpPr>
              <a:xfrm>
                <a:off x="1479672" y="1486027"/>
                <a:ext cx="1659125" cy="580129"/>
                <a:chOff x="779317" y="3463"/>
                <a:chExt cx="3655586" cy="1278211"/>
              </a:xfrm>
            </p:grpSpPr>
            <p:sp>
              <p:nvSpPr>
                <p:cNvPr id="45" name="TextBox 8">
                  <a:extLst>
                    <a:ext uri="{FF2B5EF4-FFF2-40B4-BE49-F238E27FC236}">
                      <a16:creationId xmlns:a16="http://schemas.microsoft.com/office/drawing/2014/main" id="{585E8134-65E7-43D8-B08A-22D8075AD7EC}"/>
                    </a:ext>
                  </a:extLst>
                </p:cNvPr>
                <p:cNvSpPr txBox="1"/>
                <p:nvPr/>
              </p:nvSpPr>
              <p:spPr>
                <a:xfrm>
                  <a:off x="779317" y="3463"/>
                  <a:ext cx="2022514" cy="1254780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ctr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000" b="1" dirty="0"/>
                    <a:t>G</a:t>
                  </a:r>
                  <a:r>
                    <a:rPr lang="en-SG" sz="1000" b="1" dirty="0"/>
                    <a:t>HR+/+</a:t>
                  </a:r>
                </a:p>
              </p:txBody>
            </p:sp>
            <p:sp>
              <p:nvSpPr>
                <p:cNvPr id="46" name="TextBox 9">
                  <a:extLst>
                    <a:ext uri="{FF2B5EF4-FFF2-40B4-BE49-F238E27FC236}">
                      <a16:creationId xmlns:a16="http://schemas.microsoft.com/office/drawing/2014/main" id="{F09BE7C3-266A-42F2-A304-A4FCA5B1E233}"/>
                    </a:ext>
                  </a:extLst>
                </p:cNvPr>
                <p:cNvSpPr txBox="1"/>
                <p:nvPr/>
              </p:nvSpPr>
              <p:spPr>
                <a:xfrm>
                  <a:off x="2411370" y="26893"/>
                  <a:ext cx="2023533" cy="1254781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ctr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000" b="1" dirty="0"/>
                    <a:t>GHR+/-</a:t>
                  </a:r>
                  <a:endParaRPr lang="en-SG" sz="1000" b="1" dirty="0"/>
                </a:p>
              </p:txBody>
            </p:sp>
          </p:grpSp>
          <p:sp>
            <p:nvSpPr>
              <p:cNvPr id="47" name="TextBox 22">
                <a:extLst>
                  <a:ext uri="{FF2B5EF4-FFF2-40B4-BE49-F238E27FC236}">
                    <a16:creationId xmlns:a16="http://schemas.microsoft.com/office/drawing/2014/main" id="{5A62759D-DED7-40D8-ACB0-AC2780B2CAE3}"/>
                  </a:ext>
                </a:extLst>
              </p:cNvPr>
              <p:cNvSpPr txBox="1"/>
              <p:nvPr/>
            </p:nvSpPr>
            <p:spPr>
              <a:xfrm>
                <a:off x="9600774" y="1619294"/>
                <a:ext cx="1746825" cy="348581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SG" sz="1000" b="1" dirty="0"/>
                  <a:t>AAV8-HLP-mGHR</a:t>
                </a:r>
              </a:p>
            </p:txBody>
          </p:sp>
          <p:sp>
            <p:nvSpPr>
              <p:cNvPr id="48" name="TextBox 23">
                <a:extLst>
                  <a:ext uri="{FF2B5EF4-FFF2-40B4-BE49-F238E27FC236}">
                    <a16:creationId xmlns:a16="http://schemas.microsoft.com/office/drawing/2014/main" id="{99657EB7-77AD-413D-BAEE-B9A41FFECBC8}"/>
                  </a:ext>
                </a:extLst>
              </p:cNvPr>
              <p:cNvSpPr txBox="1"/>
              <p:nvPr/>
            </p:nvSpPr>
            <p:spPr>
              <a:xfrm>
                <a:off x="4881275" y="1619294"/>
                <a:ext cx="1473099" cy="348581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SG" sz="1000" b="1" dirty="0"/>
                  <a:t>AAV8-HLP-Luc</a:t>
                </a:r>
                <a:r>
                  <a:rPr lang="en-SG" sz="1000" b="1" baseline="0" dirty="0"/>
                  <a:t>    </a:t>
                </a:r>
                <a:endParaRPr lang="en-SG" sz="1000" b="1" dirty="0"/>
              </a:p>
            </p:txBody>
          </p:sp>
          <p:sp>
            <p:nvSpPr>
              <p:cNvPr id="49" name="TextBox 10">
                <a:extLst>
                  <a:ext uri="{FF2B5EF4-FFF2-40B4-BE49-F238E27FC236}">
                    <a16:creationId xmlns:a16="http://schemas.microsoft.com/office/drawing/2014/main" id="{541412F5-7927-40D7-B667-A95B438FDD49}"/>
                  </a:ext>
                </a:extLst>
              </p:cNvPr>
              <p:cNvSpPr txBox="1"/>
              <p:nvPr/>
            </p:nvSpPr>
            <p:spPr>
              <a:xfrm>
                <a:off x="3021506" y="1486027"/>
                <a:ext cx="917939" cy="569495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b="1" dirty="0"/>
                  <a:t>G</a:t>
                </a:r>
                <a:r>
                  <a:rPr lang="en-SG" sz="1000" b="1" dirty="0"/>
                  <a:t>HR-/-</a:t>
                </a:r>
              </a:p>
            </p:txBody>
          </p:sp>
          <p:sp>
            <p:nvSpPr>
              <p:cNvPr id="50" name="TextBox 23">
                <a:extLst>
                  <a:ext uri="{FF2B5EF4-FFF2-40B4-BE49-F238E27FC236}">
                    <a16:creationId xmlns:a16="http://schemas.microsoft.com/office/drawing/2014/main" id="{ED330346-7822-4F5D-8C90-5E5004545B5B}"/>
                  </a:ext>
                </a:extLst>
              </p:cNvPr>
              <p:cNvSpPr txBox="1"/>
              <p:nvPr/>
            </p:nvSpPr>
            <p:spPr>
              <a:xfrm>
                <a:off x="8345140" y="1619294"/>
                <a:ext cx="1473099" cy="348581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SG" sz="1000" b="1" dirty="0"/>
                  <a:t>AAV8-HLP-Luc</a:t>
                </a:r>
                <a:r>
                  <a:rPr lang="en-SG" sz="1000" b="1" baseline="0" dirty="0"/>
                  <a:t>    </a:t>
                </a:r>
                <a:endParaRPr lang="en-SG" sz="1000" b="1" dirty="0"/>
              </a:p>
            </p:txBody>
          </p:sp>
          <p:sp>
            <p:nvSpPr>
              <p:cNvPr id="51" name="Left Brace 50">
                <a:extLst>
                  <a:ext uri="{FF2B5EF4-FFF2-40B4-BE49-F238E27FC236}">
                    <a16:creationId xmlns:a16="http://schemas.microsoft.com/office/drawing/2014/main" id="{B53A93B1-47A6-4761-AF38-F1746A0A6213}"/>
                  </a:ext>
                </a:extLst>
              </p:cNvPr>
              <p:cNvSpPr/>
              <p:nvPr/>
            </p:nvSpPr>
            <p:spPr>
              <a:xfrm rot="5400000">
                <a:off x="10376318" y="1011694"/>
                <a:ext cx="104332" cy="1800226"/>
              </a:xfrm>
              <a:prstGeom prst="leftBrace">
                <a:avLst>
                  <a:gd name="adj1" fmla="val 69196"/>
                  <a:gd name="adj2" fmla="val 52241"/>
                </a:avLst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SG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61861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4B14EA82-140F-4178-86DF-DBBC590EBDA2}"/>
              </a:ext>
            </a:extLst>
          </p:cNvPr>
          <p:cNvSpPr txBox="1"/>
          <p:nvPr/>
        </p:nvSpPr>
        <p:spPr>
          <a:xfrm>
            <a:off x="333127" y="1517290"/>
            <a:ext cx="1240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ig. 2aii</a:t>
            </a:r>
            <a:endParaRPr lang="en-SG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9CD44A7-9439-43D4-80EB-BC179416E0C0}"/>
              </a:ext>
            </a:extLst>
          </p:cNvPr>
          <p:cNvSpPr txBox="1"/>
          <p:nvPr/>
        </p:nvSpPr>
        <p:spPr>
          <a:xfrm>
            <a:off x="1573247" y="1517290"/>
            <a:ext cx="1240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emale</a:t>
            </a:r>
            <a:endParaRPr lang="en-SG" b="1" dirty="0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39DE800B-52E7-43DA-9C88-70F2C3E8A8FC}"/>
              </a:ext>
            </a:extLst>
          </p:cNvPr>
          <p:cNvGrpSpPr/>
          <p:nvPr/>
        </p:nvGrpSpPr>
        <p:grpSpPr>
          <a:xfrm>
            <a:off x="607757" y="1886622"/>
            <a:ext cx="10974121" cy="3235546"/>
            <a:chOff x="607757" y="1886622"/>
            <a:chExt cx="10974121" cy="323554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9024455-BF6A-451E-8795-BAF7C2DD026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984926" y="2421406"/>
              <a:ext cx="3596952" cy="2700762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690CC0E-7419-4DA1-B825-84860EC7DE7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92886" y="2421406"/>
              <a:ext cx="3603048" cy="2700762"/>
            </a:xfrm>
            <a:prstGeom prst="rect">
              <a:avLst/>
            </a:prstGeom>
          </p:spPr>
        </p:pic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F1F6C24E-B9B9-4C05-98FF-716A1DBB33E8}"/>
                </a:ext>
              </a:extLst>
            </p:cNvPr>
            <p:cNvGrpSpPr/>
            <p:nvPr/>
          </p:nvGrpSpPr>
          <p:grpSpPr>
            <a:xfrm>
              <a:off x="1514506" y="1886622"/>
              <a:ext cx="1659125" cy="580129"/>
              <a:chOff x="779317" y="3463"/>
              <a:chExt cx="3655586" cy="1278211"/>
            </a:xfrm>
          </p:grpSpPr>
          <p:sp>
            <p:nvSpPr>
              <p:cNvPr id="16" name="TextBox 8">
                <a:extLst>
                  <a:ext uri="{FF2B5EF4-FFF2-40B4-BE49-F238E27FC236}">
                    <a16:creationId xmlns:a16="http://schemas.microsoft.com/office/drawing/2014/main" id="{435DBFC0-3829-4B2F-9255-89258CE9D848}"/>
                  </a:ext>
                </a:extLst>
              </p:cNvPr>
              <p:cNvSpPr txBox="1"/>
              <p:nvPr/>
            </p:nvSpPr>
            <p:spPr>
              <a:xfrm>
                <a:off x="779317" y="3463"/>
                <a:ext cx="2022514" cy="1254780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b="1" dirty="0"/>
                  <a:t>G</a:t>
                </a:r>
                <a:r>
                  <a:rPr lang="en-SG" sz="1000" b="1" dirty="0"/>
                  <a:t>HR+/+</a:t>
                </a:r>
              </a:p>
            </p:txBody>
          </p:sp>
          <p:sp>
            <p:nvSpPr>
              <p:cNvPr id="17" name="TextBox 9">
                <a:extLst>
                  <a:ext uri="{FF2B5EF4-FFF2-40B4-BE49-F238E27FC236}">
                    <a16:creationId xmlns:a16="http://schemas.microsoft.com/office/drawing/2014/main" id="{87A1819A-11F0-4D5F-AC6D-D85D843842DB}"/>
                  </a:ext>
                </a:extLst>
              </p:cNvPr>
              <p:cNvSpPr txBox="1"/>
              <p:nvPr/>
            </p:nvSpPr>
            <p:spPr>
              <a:xfrm>
                <a:off x="2411370" y="26893"/>
                <a:ext cx="2023533" cy="1254781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000" b="1" dirty="0"/>
                  <a:t>GHR+/-</a:t>
                </a:r>
                <a:endParaRPr lang="en-SG" sz="1000" b="1" dirty="0"/>
              </a:p>
            </p:txBody>
          </p:sp>
        </p:grpSp>
        <p:sp>
          <p:nvSpPr>
            <p:cNvPr id="9" name="TextBox 22">
              <a:extLst>
                <a:ext uri="{FF2B5EF4-FFF2-40B4-BE49-F238E27FC236}">
                  <a16:creationId xmlns:a16="http://schemas.microsoft.com/office/drawing/2014/main" id="{33B0E1B9-D4D7-4B1E-929F-4BE658318258}"/>
                </a:ext>
              </a:extLst>
            </p:cNvPr>
            <p:cNvSpPr txBox="1"/>
            <p:nvPr/>
          </p:nvSpPr>
          <p:spPr>
            <a:xfrm>
              <a:off x="9635608" y="2019889"/>
              <a:ext cx="1746825" cy="34858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SG" sz="1000" b="1" dirty="0"/>
                <a:t>AAV8-HLP-mGHR</a:t>
              </a:r>
            </a:p>
          </p:txBody>
        </p:sp>
        <p:sp>
          <p:nvSpPr>
            <p:cNvPr id="10" name="TextBox 23">
              <a:extLst>
                <a:ext uri="{FF2B5EF4-FFF2-40B4-BE49-F238E27FC236}">
                  <a16:creationId xmlns:a16="http://schemas.microsoft.com/office/drawing/2014/main" id="{3432253A-80F0-45FD-99F7-AD47B1D5DD90}"/>
                </a:ext>
              </a:extLst>
            </p:cNvPr>
            <p:cNvSpPr txBox="1"/>
            <p:nvPr/>
          </p:nvSpPr>
          <p:spPr>
            <a:xfrm>
              <a:off x="6083058" y="2019889"/>
              <a:ext cx="1473099" cy="34858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SG" sz="1000" b="1" dirty="0"/>
                <a:t>AAV8-HLP-Luc</a:t>
              </a:r>
              <a:r>
                <a:rPr lang="en-SG" sz="1000" b="1" baseline="0" dirty="0"/>
                <a:t>    </a:t>
              </a:r>
              <a:endParaRPr lang="en-SG" sz="1000" b="1" dirty="0"/>
            </a:p>
          </p:txBody>
        </p:sp>
        <p:sp>
          <p:nvSpPr>
            <p:cNvPr id="30" name="TextBox 10">
              <a:extLst>
                <a:ext uri="{FF2B5EF4-FFF2-40B4-BE49-F238E27FC236}">
                  <a16:creationId xmlns:a16="http://schemas.microsoft.com/office/drawing/2014/main" id="{59389DD3-473E-46FA-B921-11B068006970}"/>
                </a:ext>
              </a:extLst>
            </p:cNvPr>
            <p:cNvSpPr txBox="1"/>
            <p:nvPr/>
          </p:nvSpPr>
          <p:spPr>
            <a:xfrm>
              <a:off x="3056340" y="1886622"/>
              <a:ext cx="917939" cy="56949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b="1" dirty="0"/>
                <a:t>G</a:t>
              </a:r>
              <a:r>
                <a:rPr lang="en-SG" sz="1000" b="1" dirty="0"/>
                <a:t>HR-/-</a:t>
              </a:r>
            </a:p>
          </p:txBody>
        </p:sp>
        <p:sp>
          <p:nvSpPr>
            <p:cNvPr id="23" name="TextBox 23">
              <a:extLst>
                <a:ext uri="{FF2B5EF4-FFF2-40B4-BE49-F238E27FC236}">
                  <a16:creationId xmlns:a16="http://schemas.microsoft.com/office/drawing/2014/main" id="{3D6531A2-37B3-4737-A510-616EF0488224}"/>
                </a:ext>
              </a:extLst>
            </p:cNvPr>
            <p:cNvSpPr txBox="1"/>
            <p:nvPr/>
          </p:nvSpPr>
          <p:spPr>
            <a:xfrm>
              <a:off x="8379974" y="2019889"/>
              <a:ext cx="1473099" cy="34858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SG" sz="1000" b="1" dirty="0"/>
                <a:t>AAV8-HLP-Luc</a:t>
              </a:r>
              <a:r>
                <a:rPr lang="en-SG" sz="1000" b="1" baseline="0" dirty="0"/>
                <a:t>    </a:t>
              </a:r>
              <a:endParaRPr lang="en-SG" sz="1000" b="1" dirty="0"/>
            </a:p>
          </p:txBody>
        </p:sp>
        <p:sp>
          <p:nvSpPr>
            <p:cNvPr id="24" name="Left Brace 23">
              <a:extLst>
                <a:ext uri="{FF2B5EF4-FFF2-40B4-BE49-F238E27FC236}">
                  <a16:creationId xmlns:a16="http://schemas.microsoft.com/office/drawing/2014/main" id="{9ABD9CB7-E4F1-4566-8B47-86F06DC65178}"/>
                </a:ext>
              </a:extLst>
            </p:cNvPr>
            <p:cNvSpPr/>
            <p:nvPr/>
          </p:nvSpPr>
          <p:spPr>
            <a:xfrm rot="5400000">
              <a:off x="10411152" y="1412289"/>
              <a:ext cx="104332" cy="1800226"/>
            </a:xfrm>
            <a:prstGeom prst="leftBrace">
              <a:avLst>
                <a:gd name="adj1" fmla="val 69196"/>
                <a:gd name="adj2" fmla="val 52241"/>
              </a:avLst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pic>
          <p:nvPicPr>
            <p:cNvPr id="19" name="Picture 18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890CB7D0-FACA-4CCC-BE1D-8BA23BB3A16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1057757" y="1962698"/>
              <a:ext cx="2700000" cy="360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0799341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FB7F84E5-549A-498D-A7E4-DB9118AB1080}"/>
              </a:ext>
            </a:extLst>
          </p:cNvPr>
          <p:cNvSpPr txBox="1"/>
          <p:nvPr/>
        </p:nvSpPr>
        <p:spPr>
          <a:xfrm>
            <a:off x="1447603" y="101229"/>
            <a:ext cx="1240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ig. 5b</a:t>
            </a:r>
            <a:endParaRPr lang="en-SG" b="1" dirty="0"/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A6B961E8-96D4-412C-BD3E-289FA2488AD3}"/>
              </a:ext>
            </a:extLst>
          </p:cNvPr>
          <p:cNvGrpSpPr/>
          <p:nvPr/>
        </p:nvGrpSpPr>
        <p:grpSpPr>
          <a:xfrm>
            <a:off x="1736227" y="405737"/>
            <a:ext cx="8897928" cy="6250180"/>
            <a:chOff x="1553347" y="432376"/>
            <a:chExt cx="8897928" cy="6250180"/>
          </a:xfrm>
        </p:grpSpPr>
        <p:sp>
          <p:nvSpPr>
            <p:cNvPr id="14" name="TextBox 4">
              <a:extLst>
                <a:ext uri="{FF2B5EF4-FFF2-40B4-BE49-F238E27FC236}">
                  <a16:creationId xmlns:a16="http://schemas.microsoft.com/office/drawing/2014/main" id="{3C611FA0-E956-4AA3-A34A-E9BF5377D005}"/>
                </a:ext>
              </a:extLst>
            </p:cNvPr>
            <p:cNvSpPr txBox="1"/>
            <p:nvPr/>
          </p:nvSpPr>
          <p:spPr>
            <a:xfrm>
              <a:off x="5984096" y="446507"/>
              <a:ext cx="1101138" cy="38079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>
              <a:normAutofit/>
            </a:bodyPr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SG" sz="1200" b="1" dirty="0"/>
                <a:t>AAV8-HLP-Luc</a:t>
              </a:r>
            </a:p>
          </p:txBody>
        </p:sp>
        <p:sp>
          <p:nvSpPr>
            <p:cNvPr id="15" name="TextBox 3">
              <a:extLst>
                <a:ext uri="{FF2B5EF4-FFF2-40B4-BE49-F238E27FC236}">
                  <a16:creationId xmlns:a16="http://schemas.microsoft.com/office/drawing/2014/main" id="{82363A46-E239-4F29-822B-4CA7F110EAC9}"/>
                </a:ext>
              </a:extLst>
            </p:cNvPr>
            <p:cNvSpPr txBox="1"/>
            <p:nvPr/>
          </p:nvSpPr>
          <p:spPr>
            <a:xfrm>
              <a:off x="4737288" y="446507"/>
              <a:ext cx="1297270" cy="40905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>
              <a:normAutofit/>
            </a:bodyPr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SG" sz="1200" b="1" dirty="0"/>
                <a:t>AAV8-HLP-mGHR</a:t>
              </a:r>
            </a:p>
          </p:txBody>
        </p:sp>
        <p:sp>
          <p:nvSpPr>
            <p:cNvPr id="16" name="TextBox 3">
              <a:extLst>
                <a:ext uri="{FF2B5EF4-FFF2-40B4-BE49-F238E27FC236}">
                  <a16:creationId xmlns:a16="http://schemas.microsoft.com/office/drawing/2014/main" id="{123BCCDE-FBE5-4743-9F5A-7BCF7DF96CF2}"/>
                </a:ext>
              </a:extLst>
            </p:cNvPr>
            <p:cNvSpPr txBox="1"/>
            <p:nvPr/>
          </p:nvSpPr>
          <p:spPr>
            <a:xfrm>
              <a:off x="2015542" y="432376"/>
              <a:ext cx="1297270" cy="40905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>
              <a:normAutofit/>
            </a:bodyPr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SG" sz="1200" b="1" dirty="0"/>
                <a:t>AAV8-HLP-mGHR</a:t>
              </a:r>
            </a:p>
          </p:txBody>
        </p:sp>
        <p:sp>
          <p:nvSpPr>
            <p:cNvPr id="17" name="TextBox 4">
              <a:extLst>
                <a:ext uri="{FF2B5EF4-FFF2-40B4-BE49-F238E27FC236}">
                  <a16:creationId xmlns:a16="http://schemas.microsoft.com/office/drawing/2014/main" id="{354DFD5B-EC20-47EB-AD92-3F937C2625E8}"/>
                </a:ext>
              </a:extLst>
            </p:cNvPr>
            <p:cNvSpPr txBox="1"/>
            <p:nvPr/>
          </p:nvSpPr>
          <p:spPr>
            <a:xfrm>
              <a:off x="8863102" y="451812"/>
              <a:ext cx="1101138" cy="38079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>
              <a:normAutofit/>
            </a:bodyPr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lnSpc>
                  <a:spcPct val="90000"/>
                </a:lnSpc>
                <a:spcAft>
                  <a:spcPts val="600"/>
                </a:spcAft>
              </a:pPr>
              <a:r>
                <a:rPr lang="en-SG" sz="1200" b="1" dirty="0"/>
                <a:t>AAV8-HLP-Luc</a:t>
              </a:r>
            </a:p>
          </p:txBody>
        </p:sp>
        <p:pic>
          <p:nvPicPr>
            <p:cNvPr id="3" name="Picture 2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FDDBFE0A-4F4C-47C2-877F-0734F8E2B1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061888" y="1536814"/>
              <a:ext cx="5880848" cy="4410636"/>
            </a:xfrm>
            <a:prstGeom prst="rect">
              <a:avLst/>
            </a:prstGeom>
          </p:spPr>
        </p:pic>
        <p:pic>
          <p:nvPicPr>
            <p:cNvPr id="6" name="Picture 5" descr="A picture containing measuring stick&#10;&#10;Description automatically generated">
              <a:extLst>
                <a:ext uri="{FF2B5EF4-FFF2-40B4-BE49-F238E27FC236}">
                  <a16:creationId xmlns:a16="http://schemas.microsoft.com/office/drawing/2014/main" id="{3D675ADD-0254-4F71-A38F-82B500968C5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1193348" y="1161708"/>
              <a:ext cx="2880000" cy="216000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906CF387-4907-41F0-ADDF-51A8855E6C2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193347" y="4162556"/>
              <a:ext cx="2880000" cy="2160000"/>
            </a:xfrm>
            <a:prstGeom prst="rect">
              <a:avLst/>
            </a:prstGeom>
          </p:spPr>
        </p:pic>
        <p:pic>
          <p:nvPicPr>
            <p:cNvPr id="20" name="Picture 19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513D3C33-6306-47F4-9EA1-2E07F083D3D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7931275" y="1161707"/>
              <a:ext cx="2880000" cy="2160000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68466091-20DF-4578-AEE0-BE47712D5D5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7931275" y="4162556"/>
              <a:ext cx="2880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05310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61</TotalTime>
  <Words>58</Words>
  <Application>Microsoft Office PowerPoint</Application>
  <PresentationFormat>Widescreen</PresentationFormat>
  <Paragraphs>24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a Kian Chuan</dc:creator>
  <cp:lastModifiedBy>Sia Kian Chuan</cp:lastModifiedBy>
  <cp:revision>857</cp:revision>
  <cp:lastPrinted>2021-04-26T06:20:07Z</cp:lastPrinted>
  <dcterms:created xsi:type="dcterms:W3CDTF">2019-05-14T08:27:17Z</dcterms:created>
  <dcterms:modified xsi:type="dcterms:W3CDTF">2021-12-10T05:09:22Z</dcterms:modified>
</cp:coreProperties>
</file>